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rat Bagha" initials="MB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A5"/>
    <a:srgbClr val="2F5597"/>
    <a:srgbClr val="007098"/>
    <a:srgbClr val="FFC000"/>
    <a:srgbClr val="E6E6E6"/>
    <a:srgbClr val="00B050"/>
    <a:srgbClr val="0C5882"/>
    <a:srgbClr val="0B5882"/>
    <a:srgbClr val="007097"/>
    <a:srgbClr val="FFD9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-112" y="-5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1B3A52-9C11-DE48-8CC0-104A647BC746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895EF6-8338-224C-8731-9E89DD4A1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580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05837-44FE-4697-A465-ED5A13A929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B815682-DA19-4813-AD13-4EC0E64481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6834218-596C-46D8-8157-9050CC141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2D111F2-9794-486E-90E2-63D5D67E6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258C388-3162-4C73-A1C6-0C75695F0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19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0DC4C4-FE14-4460-8232-F04345519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65F2FB6-87E8-43CE-A50E-707DA4F6C4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1BBEAD2-75C4-47FB-939C-32535B3B3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CEBC50-A90E-4F43-ADB4-258787EB3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B6021C3-ECF0-4126-A815-298067FB4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124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0B6D50D9-819A-43F1-A92F-C7BF3A538C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B374FDFA-E6F6-4812-BACA-6E54FE4D7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8B9E568-8CB5-45DC-8E8A-9EDC71C6A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373664B-7588-4585-BD0C-1E6E11D02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FC39804-BA91-4EA1-80E1-6BB89904C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214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D65E8AD-FEC3-46A1-9F7F-525FFB333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09381BB-97E5-4DE6-B969-FAF52D16C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B3C86E2-A2EF-4601-BFDB-31B0FEF1C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FFC0143-D542-4E5F-9773-301F1BD57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B6FC666-DFBD-448D-B7CE-04E5DF703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5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9CB79B4-D0B3-4B86-A059-94B712EC5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6AB63C-6A3C-4E17-836A-5F006C416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319F62D-10B6-4C87-AAD7-75185A43B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53764DF-2E6A-48B1-A782-1133B1FB2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191A2BF-A193-43FE-BD09-C21FD079A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1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F5658-FB35-4144-8BD4-74EEB671D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2B149B-3C2A-4FB5-A239-1D7D8F722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5BCC1F6-0FF7-4A2C-A584-2242DC21FC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18F72D4-66EB-4D65-B6CB-C5893BBF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1FA55F2-32F4-4CB7-B59E-B20D76800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6B707D9-514F-43C1-9166-681A55DBA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13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5E1F58B-E858-4F5A-8307-E25749AA0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48945E2-A55C-4EF4-99A5-E9D94C2C83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4D21E10-4E4A-4A9B-8665-CC047E7902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714CC3FC-2497-409F-8AC3-61293C5ABF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E6C7CB3D-6B75-457C-8C17-721BA068A3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AEDC7E2F-B0D5-464A-BE2C-29C3B56D8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83EF950B-3973-427A-AE34-5CED434A0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D6C1A0E0-4B27-4E11-AA50-1CCFA4B77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4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198F535-A3A4-4082-92F6-3DE35B200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05710233-981B-4341-9BDC-B036BF53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AE97D9FD-BA35-45C3-9FD6-46C426944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8DC67DE-2F0B-4B18-8F06-9EDDF18FF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06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B8F7090-1EE7-47F3-B760-2C61F9D74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0B690DB5-9534-4AD8-8550-0DBCB427B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15480695-A8C6-4615-818D-A068CB5D3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41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DCFD880-C7BC-4A9F-9284-51D0CC101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F52F9D1-E005-4C9B-9E13-AFDF44196B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F2F25E1-1CDE-4434-8B92-53DDA6B2C9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F8016F1-B9EF-4838-A85C-74986DCC5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31C4F04-F159-453E-A6B9-B55DFBD5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E565885-8DD0-4ABA-82EA-FD85906A9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81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F2502AA-F3DC-4104-92FF-0DA5A51935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91FE64B-A526-465E-A981-B0BAC54252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4E23C09-CF58-42B5-A10F-7B10E1DE0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4E10560-47AE-4258-B707-72DDCF552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8BC694B-5031-4723-B9A3-F1179FCEC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F0E08D3-B771-4554-A70D-47A550345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2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376867A7-BD58-4E51-95DB-58B88D079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3A05465-645A-4AC0-B322-1A4891808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171DFF0-7F94-4D7A-AEDE-45F3DFCD42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DCA8706-B7AA-43F1-A378-8AA892861D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6FEA253-09BA-41BF-ADCE-61F3048022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186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5" name="Straight Connector 64"/>
          <p:cNvCxnSpPr>
            <a:stCxn id="62" idx="1"/>
          </p:cNvCxnSpPr>
          <p:nvPr/>
        </p:nvCxnSpPr>
        <p:spPr>
          <a:xfrm flipH="1" flipV="1">
            <a:off x="6330451" y="6125462"/>
            <a:ext cx="792177" cy="2607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H="1" flipV="1">
            <a:off x="5825826" y="5217091"/>
            <a:ext cx="0" cy="3742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>
            <a:stCxn id="23" idx="1"/>
          </p:cNvCxnSpPr>
          <p:nvPr/>
        </p:nvCxnSpPr>
        <p:spPr>
          <a:xfrm flipH="1">
            <a:off x="7502122" y="1238976"/>
            <a:ext cx="463723" cy="16562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>
            <a:stCxn id="15" idx="1"/>
            <a:endCxn id="12" idx="6"/>
          </p:cNvCxnSpPr>
          <p:nvPr/>
        </p:nvCxnSpPr>
        <p:spPr>
          <a:xfrm flipH="1" flipV="1">
            <a:off x="8704906" y="2459676"/>
            <a:ext cx="499618" cy="6803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>
            <a:stCxn id="14" idx="1"/>
          </p:cNvCxnSpPr>
          <p:nvPr/>
        </p:nvCxnSpPr>
        <p:spPr>
          <a:xfrm flipH="1">
            <a:off x="8550593" y="3630477"/>
            <a:ext cx="191678" cy="354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H="1">
            <a:off x="5069254" y="4891802"/>
            <a:ext cx="240530" cy="12507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>
            <a:stCxn id="11" idx="3"/>
          </p:cNvCxnSpPr>
          <p:nvPr/>
        </p:nvCxnSpPr>
        <p:spPr>
          <a:xfrm>
            <a:off x="3949694" y="1178658"/>
            <a:ext cx="499435" cy="42199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H="1">
            <a:off x="3740400" y="5196800"/>
            <a:ext cx="284809" cy="2856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flipV="1">
            <a:off x="3979090" y="3246357"/>
            <a:ext cx="234494" cy="14215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907629" y="3273211"/>
            <a:ext cx="219432" cy="13249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>
            <a:stCxn id="10" idx="3"/>
          </p:cNvCxnSpPr>
          <p:nvPr/>
        </p:nvCxnSpPr>
        <p:spPr>
          <a:xfrm>
            <a:off x="2876695" y="2342444"/>
            <a:ext cx="243582" cy="124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3988749" y="2615914"/>
            <a:ext cx="199136" cy="10258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>
            <a:off x="4716372" y="2282732"/>
            <a:ext cx="49843" cy="1916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7378109" y="3282704"/>
            <a:ext cx="233057" cy="12726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H="1">
            <a:off x="6950693" y="2104069"/>
            <a:ext cx="22373" cy="33324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>
            <a:off x="7481444" y="2674634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809279" y="3992100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>
            <a:off x="6304538" y="3243648"/>
            <a:ext cx="209774" cy="896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 flipV="1">
            <a:off x="5094587" y="3238819"/>
            <a:ext cx="221316" cy="869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 flipV="1">
            <a:off x="6321029" y="4854418"/>
            <a:ext cx="260888" cy="937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Oval 1"/>
          <p:cNvSpPr>
            <a:spLocks noChangeAspect="1"/>
          </p:cNvSpPr>
          <p:nvPr/>
        </p:nvSpPr>
        <p:spPr>
          <a:xfrm>
            <a:off x="4108283" y="2463135"/>
            <a:ext cx="1079999" cy="1079999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/>
          <a:lstStyle/>
          <a:p>
            <a:pPr algn="ctr"/>
            <a:r>
              <a:rPr lang="en-US" sz="1100" smtClean="0">
                <a:solidFill>
                  <a:schemeClr val="tx1"/>
                </a:solidFill>
                <a:latin typeface="Arial"/>
                <a:cs typeface="Arial"/>
              </a:rPr>
              <a:t>Opportunities</a:t>
            </a:r>
            <a:endParaRPr lang="en-US" sz="110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3" name="Oval 2"/>
          <p:cNvSpPr>
            <a:spLocks noChangeAspect="1"/>
          </p:cNvSpPr>
          <p:nvPr/>
        </p:nvSpPr>
        <p:spPr>
          <a:xfrm>
            <a:off x="6425180" y="2442147"/>
            <a:ext cx="1080000" cy="108000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Challenges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" name="Oval 3"/>
          <p:cNvSpPr>
            <a:spLocks noChangeAspect="1"/>
          </p:cNvSpPr>
          <p:nvPr/>
        </p:nvSpPr>
        <p:spPr>
          <a:xfrm>
            <a:off x="5262593" y="2934414"/>
            <a:ext cx="1080000" cy="1080000"/>
          </a:xfrm>
          <a:prstGeom prst="ellipse">
            <a:avLst/>
          </a:prstGeom>
          <a:solidFill>
            <a:srgbClr val="00B050">
              <a:alpha val="50000"/>
            </a:srgb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b="1" smtClean="0">
                <a:solidFill>
                  <a:srgbClr val="000000"/>
                </a:solidFill>
                <a:latin typeface="Arial"/>
                <a:cs typeface="Arial"/>
              </a:rPr>
              <a:t>Patients/ Parents/ Caregivers</a:t>
            </a:r>
            <a:endParaRPr lang="en-US" sz="1100" b="1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5270679" y="4193333"/>
            <a:ext cx="1080000" cy="1080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eHealth Tools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>
            <a:off x="4308597" y="1194991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" name="Oval 6"/>
          <p:cNvSpPr>
            <a:spLocks noChangeAspect="1"/>
          </p:cNvSpPr>
          <p:nvPr/>
        </p:nvSpPr>
        <p:spPr>
          <a:xfrm>
            <a:off x="3019402" y="1807103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Clinical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" name="Oval 7"/>
          <p:cNvSpPr>
            <a:spLocks noChangeAspect="1"/>
          </p:cNvSpPr>
          <p:nvPr/>
        </p:nvSpPr>
        <p:spPr>
          <a:xfrm>
            <a:off x="3019404" y="3106058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Process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5831" y="3053039"/>
            <a:ext cx="2828524" cy="430887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Alarms and memory functions to prompt administration 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3983" y="1957723"/>
            <a:ext cx="2762712" cy="76944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Games to decrease anxiety and pain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Patient-based choice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Patient involvement in expectations of therapy and outcomes 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5030" y="709298"/>
            <a:ext cx="3764664" cy="93871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Appropriate words to explain quality of life to patient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Group support related to child’s condition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Incentives for adherence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Continuing education about condition and therapy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Tools to improve motivation and behavioural changes 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12" name="Oval 11"/>
          <p:cNvSpPr>
            <a:spLocks noChangeAspect="1"/>
          </p:cNvSpPr>
          <p:nvPr/>
        </p:nvSpPr>
        <p:spPr>
          <a:xfrm>
            <a:off x="7624906" y="1919676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Clinical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7481937" y="3168165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Process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742271" y="3330395"/>
            <a:ext cx="2653890" cy="60016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Logistics of clinic visit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Therapy access, storage and friendly formulations 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204524" y="2142994"/>
            <a:ext cx="2359847" cy="76944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Assessment of quality of life during therapy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Patient ability to deal with lack of adherence 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16" name="Oval 15"/>
          <p:cNvSpPr>
            <a:spLocks noChangeAspect="1"/>
          </p:cNvSpPr>
          <p:nvPr/>
        </p:nvSpPr>
        <p:spPr>
          <a:xfrm>
            <a:off x="6539097" y="4526892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8" name="Oval 17"/>
          <p:cNvSpPr>
            <a:spLocks noChangeAspect="1"/>
          </p:cNvSpPr>
          <p:nvPr/>
        </p:nvSpPr>
        <p:spPr>
          <a:xfrm>
            <a:off x="4025702" y="4590876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Process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04262" y="5020944"/>
            <a:ext cx="2955127" cy="43088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Personalized access to HCP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Home measurements and telemedicine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971072" y="5085066"/>
            <a:ext cx="2974370" cy="430887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Games to support adherence and decrease anxiety</a:t>
            </a:r>
            <a:endParaRPr lang="en-US" sz="1100">
              <a:latin typeface="Arial"/>
              <a:cs typeface="Arial"/>
            </a:endParaRPr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>
            <a:off x="6470178" y="1156039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965845" y="689885"/>
            <a:ext cx="3859249" cy="109818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lIns="72000" tIns="36000" rIns="36000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Maintaining trust in therapy, physician/nurse and device, with managed expectation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Information on possible side effects, to reduce fear of them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Injection techniques to minimize painful injection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Maintaining knowledge over time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Importance of good nutrition and activity </a:t>
            </a:r>
            <a:endParaRPr lang="en-US" sz="1100">
              <a:latin typeface="Arial"/>
              <a:cs typeface="Arial"/>
            </a:endParaRPr>
          </a:p>
        </p:txBody>
      </p:sp>
      <p:cxnSp>
        <p:nvCxnSpPr>
          <p:cNvPr id="26" name="Straight Connector 25"/>
          <p:cNvCxnSpPr>
            <a:stCxn id="21" idx="1"/>
          </p:cNvCxnSpPr>
          <p:nvPr/>
        </p:nvCxnSpPr>
        <p:spPr>
          <a:xfrm flipH="1" flipV="1">
            <a:off x="7619869" y="5206311"/>
            <a:ext cx="351203" cy="941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Oval 46"/>
          <p:cNvSpPr>
            <a:spLocks noChangeAspect="1"/>
          </p:cNvSpPr>
          <p:nvPr/>
        </p:nvSpPr>
        <p:spPr>
          <a:xfrm>
            <a:off x="5278550" y="5517259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smtClean="0">
                <a:solidFill>
                  <a:srgbClr val="000000"/>
                </a:solidFill>
                <a:latin typeface="Arial"/>
                <a:cs typeface="Arial"/>
              </a:rPr>
              <a:t>Clinical</a:t>
            </a:r>
            <a:endParaRPr lang="en-US" sz="11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7122628" y="5851458"/>
            <a:ext cx="3365204" cy="60016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US" sz="1100" smtClean="0">
                <a:latin typeface="Arial"/>
                <a:cs typeface="Arial"/>
              </a:rPr>
              <a:t>Online support for behavioral management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New formulations</a:t>
            </a:r>
          </a:p>
          <a:p>
            <a:pPr marL="87313" indent="-87313"/>
            <a:r>
              <a:rPr lang="en-US" sz="1100" smtClean="0">
                <a:latin typeface="Arial"/>
                <a:cs typeface="Arial"/>
              </a:rPr>
              <a:t>App to monitor height and provide daily reminders</a:t>
            </a:r>
            <a:endParaRPr lang="en-US" sz="11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14555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22</TotalTime>
  <Words>171</Words>
  <Application>Microsoft Macintosh PowerPoint</Application>
  <PresentationFormat>Custom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at Bagha</dc:creator>
  <cp:lastModifiedBy>Peter Bates</cp:lastModifiedBy>
  <cp:revision>128</cp:revision>
  <dcterms:created xsi:type="dcterms:W3CDTF">2020-06-30T04:52:24Z</dcterms:created>
  <dcterms:modified xsi:type="dcterms:W3CDTF">2021-01-26T13:17:09Z</dcterms:modified>
</cp:coreProperties>
</file>